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  <p:sldId id="26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6BFD28F-762D-49C4-9803-7A824167F00D}" v="2" dt="2021-09-08T02:09:48.67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26" autoAdjust="0"/>
    <p:restoredTop sz="94660"/>
  </p:normalViewPr>
  <p:slideViewPr>
    <p:cSldViewPr snapToGrid="0">
      <p:cViewPr varScale="1">
        <p:scale>
          <a:sx n="86" d="100"/>
          <a:sy n="86" d="100"/>
        </p:scale>
        <p:origin x="65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양경미" userId="a28efcec-ec74-4305-ada5-b4981d783a37" providerId="ADAL" clId="{36BFD28F-762D-49C4-9803-7A824167F00D}"/>
    <pc:docChg chg="addSld delSld modSld sldOrd">
      <pc:chgData name="양경미" userId="a28efcec-ec74-4305-ada5-b4981d783a37" providerId="ADAL" clId="{36BFD28F-762D-49C4-9803-7A824167F00D}" dt="2021-09-08T02:10:12.964" v="36" actId="1076"/>
      <pc:docMkLst>
        <pc:docMk/>
      </pc:docMkLst>
      <pc:sldChg chg="new del">
        <pc:chgData name="양경미" userId="a28efcec-ec74-4305-ada5-b4981d783a37" providerId="ADAL" clId="{36BFD28F-762D-49C4-9803-7A824167F00D}" dt="2021-09-08T02:08:29.756" v="2" actId="47"/>
        <pc:sldMkLst>
          <pc:docMk/>
          <pc:sldMk cId="4137040313" sldId="258"/>
        </pc:sldMkLst>
      </pc:sldChg>
      <pc:sldChg chg="add">
        <pc:chgData name="양경미" userId="a28efcec-ec74-4305-ada5-b4981d783a37" providerId="ADAL" clId="{36BFD28F-762D-49C4-9803-7A824167F00D}" dt="2021-09-08T02:08:27.718" v="1"/>
        <pc:sldMkLst>
          <pc:docMk/>
          <pc:sldMk cId="434031822" sldId="259"/>
        </pc:sldMkLst>
      </pc:sldChg>
      <pc:sldChg chg="add">
        <pc:chgData name="양경미" userId="a28efcec-ec74-4305-ada5-b4981d783a37" providerId="ADAL" clId="{36BFD28F-762D-49C4-9803-7A824167F00D}" dt="2021-09-08T02:08:27.718" v="1"/>
        <pc:sldMkLst>
          <pc:docMk/>
          <pc:sldMk cId="977851510" sldId="260"/>
        </pc:sldMkLst>
      </pc:sldChg>
      <pc:sldChg chg="modSp add mod ord">
        <pc:chgData name="양경미" userId="a28efcec-ec74-4305-ada5-b4981d783a37" providerId="ADAL" clId="{36BFD28F-762D-49C4-9803-7A824167F00D}" dt="2021-09-08T02:10:12.964" v="36" actId="1076"/>
        <pc:sldMkLst>
          <pc:docMk/>
          <pc:sldMk cId="2984754611" sldId="261"/>
        </pc:sldMkLst>
        <pc:picChg chg="mod">
          <ac:chgData name="양경미" userId="a28efcec-ec74-4305-ada5-b4981d783a37" providerId="ADAL" clId="{36BFD28F-762D-49C4-9803-7A824167F00D}" dt="2021-09-08T02:10:03.262" v="34" actId="2085"/>
          <ac:picMkLst>
            <pc:docMk/>
            <pc:sldMk cId="2984754611" sldId="261"/>
            <ac:picMk id="5" creationId="{00000000-0000-0000-0000-000000000000}"/>
          </ac:picMkLst>
        </pc:picChg>
        <pc:picChg chg="mod">
          <ac:chgData name="양경미" userId="a28efcec-ec74-4305-ada5-b4981d783a37" providerId="ADAL" clId="{36BFD28F-762D-49C4-9803-7A824167F00D}" dt="2021-09-08T02:10:08.881" v="35" actId="1076"/>
          <ac:picMkLst>
            <pc:docMk/>
            <pc:sldMk cId="2984754611" sldId="261"/>
            <ac:picMk id="7" creationId="{00000000-0000-0000-0000-000000000000}"/>
          </ac:picMkLst>
        </pc:picChg>
        <pc:picChg chg="mod">
          <ac:chgData name="양경미" userId="a28efcec-ec74-4305-ada5-b4981d783a37" providerId="ADAL" clId="{36BFD28F-762D-49C4-9803-7A824167F00D}" dt="2021-09-08T02:10:12.964" v="36" actId="1076"/>
          <ac:picMkLst>
            <pc:docMk/>
            <pc:sldMk cId="2984754611" sldId="261"/>
            <ac:picMk id="11" creationId="{00000000-0000-0000-0000-000000000000}"/>
          </ac:picMkLst>
        </pc:picChg>
      </pc:sldChg>
      <pc:sldChg chg="add">
        <pc:chgData name="양경미" userId="a28efcec-ec74-4305-ada5-b4981d783a37" providerId="ADAL" clId="{36BFD28F-762D-49C4-9803-7A824167F00D}" dt="2021-09-08T02:08:27.718" v="1"/>
        <pc:sldMkLst>
          <pc:docMk/>
          <pc:sldMk cId="75210854" sldId="262"/>
        </pc:sldMkLst>
      </pc:sldChg>
      <pc:sldChg chg="modSp new mod">
        <pc:chgData name="양경미" userId="a28efcec-ec74-4305-ada5-b4981d783a37" providerId="ADAL" clId="{36BFD28F-762D-49C4-9803-7A824167F00D}" dt="2021-09-08T02:09:50.202" v="33" actId="20577"/>
        <pc:sldMkLst>
          <pc:docMk/>
          <pc:sldMk cId="2758524959" sldId="263"/>
        </pc:sldMkLst>
        <pc:spChg chg="mod">
          <ac:chgData name="양경미" userId="a28efcec-ec74-4305-ada5-b4981d783a37" providerId="ADAL" clId="{36BFD28F-762D-49C4-9803-7A824167F00D}" dt="2021-09-08T02:09:50.202" v="33" actId="20577"/>
          <ac:spMkLst>
            <pc:docMk/>
            <pc:sldMk cId="2758524959" sldId="263"/>
            <ac:spMk id="2" creationId="{58D61F63-BB04-41D8-9376-BBC5EA87B7A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E72403D-634E-426D-A905-684E37B15C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C51B4E9-F9CB-4D18-89A6-D19A0DCF6A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F9C17EC-19A0-41A5-8606-7C8AD1982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93F66FF-A0F2-4919-B155-51DBBDCA0F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0B54094-9133-4630-AB1B-864D40789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191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618AA04-A35F-436F-BD07-8806CED29F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6A70DDE-8603-4070-9D52-AAAED4515B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47C8E76-E908-4AAA-92F7-428497218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F2707A7-06E0-4569-8FE6-26BEE0B27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EB36326-0AEE-4860-8C3B-0240863C3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743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F4894D9-0D0F-45E3-9026-71A10AA4F0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D3D2F4C-4FCA-4586-9E0C-EBA91364B4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09537EB-B7CB-49D7-BEC5-2B72E479E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C5FA7DB-2C07-4242-BAB1-C7831A4F2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5E238D1-72B2-433D-935A-8EDAAC349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984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A33564A-2BB8-41AF-86CD-41ED57017F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F0B8BA2-EB8D-4035-9F8F-ADCE5D7576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2B5E7EA-9A19-40F1-BB90-5581F75F0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5A02DBB-E9B6-499E-96C3-FD2270DDA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DC992FF-993B-4BF1-A5A9-2E64788B9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662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9218446-4AC5-4E7C-B0BB-D3EDC7B3CA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10D1D7D-7F2C-4421-BA48-EFC2FFB632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3BF782F-5B82-4E3C-9288-58A83DF31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A42D668-4B82-49E5-9DCE-D5FB720D6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345795C-342F-46C4-A621-B897C30C1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072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77E2102-C28F-4053-823C-D242C0D57F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BC7AC8F-E210-4738-8A14-71D7E6C65D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7709F81-35D6-4004-AF9B-6BE4689233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E6904FE-B325-431B-B9CB-AB0256348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156F580-D1E0-4A5B-B9D2-21F09DC25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FA750D9-B3C3-4472-9091-116923F99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449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7EAAA5-4A3A-499A-805D-EDCF4B027E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9A4F178-795A-4893-BA13-9D6BAA774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2359E59-0675-4268-B31E-860F2586B9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BDE6085-47D9-4B1D-B33B-724BC2AD9D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2EF710F1-2ED3-413E-8B7E-9AACA4B63A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2718D00-52E2-48FA-A12D-0A74FBDE2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8780D70-4F58-40D6-9C40-8419D6E62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271990F-6327-4BB8-9641-E9EFFFDFA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939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7E3986-F8B5-463E-98B8-E866633839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E9B922DA-EFEE-46CC-A7F8-362F0C8E75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8F4FF51-FBF4-41ED-A5CB-5BCBBEBCA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979D40D-D22F-48CF-BC0E-BCEFA0111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571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8662437-A800-4FBC-A1D7-A75448B7A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F1D6F84-2952-400C-A010-F01E98471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64D0BEE7-B3B9-440E-81D8-AC4E2F1BC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132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F424F45-A343-4852-882B-A5F9C2CFF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652C592-BB24-4C6A-8CA8-01386E5E32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F102D24-DCD3-4CEE-83E4-BCBB44CD33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D1E8AFA-31A0-4B5C-971F-2566A0F61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FC6B3FE-EC64-4626-94D0-4407A635E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315C5B0-CAE5-4EFE-9511-408FEA6DB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790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197D38B-36EC-4680-9790-D02E83DAC1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8C28469-FF72-4877-A4DA-3B530CC447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651F91B-7270-4771-8877-344CA1E2C4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FAF90C1-1A6A-4F62-9516-B38F99588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214693F-9CC7-4152-B130-7F5E7EB3E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403CED0-F60C-47C1-AEAF-9C6026049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091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0A5ABBF-F806-4247-AE1D-0D03741EE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B63CDA6-381B-413A-9528-A4C28E417A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3762792-D8B7-47DE-B494-47D2F94C73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7B32D-CBD6-4C50-9A6B-E5D66D2E7554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DF6E906-4B45-4931-9CB7-FF592239F9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05E034-3462-4F33-A3A6-EA8F76FBDE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E77116-2728-4B58-A1B3-576D1DCB4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05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-1" y="1"/>
            <a:ext cx="12084783" cy="965380"/>
          </a:xfrm>
        </p:spPr>
        <p:txBody>
          <a:bodyPr>
            <a:noAutofit/>
          </a:bodyPr>
          <a:lstStyle/>
          <a:p>
            <a:pPr algn="just" latinLnBrk="1">
              <a:lnSpc>
                <a:spcPct val="115000"/>
              </a:lnSpc>
              <a:spcAft>
                <a:spcPts val="1000"/>
              </a:spcAft>
            </a:pP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. Individual distribution of grade ≥3 lung complication (n=7). (A) Sorted by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ean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lung at re-RT; (B) sorted by cumulative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ean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lung; (C) sorted by re-RT techniques and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ean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lung at re-RT; (D) sorted by re-RT techniques and cumulative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ean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lung;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x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mplication; P, proton beam therapy; X, X-ray beam therapy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409" y="4023791"/>
            <a:ext cx="5895909" cy="2880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8873" y="4023127"/>
            <a:ext cx="5895910" cy="2880000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1408" y="899785"/>
            <a:ext cx="5895910" cy="288000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88873" y="896432"/>
            <a:ext cx="5895912" cy="28800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A335C5F-FC98-42D7-A9D8-17B944C18A5D}"/>
              </a:ext>
            </a:extLst>
          </p:cNvPr>
          <p:cNvSpPr txBox="1"/>
          <p:nvPr/>
        </p:nvSpPr>
        <p:spPr>
          <a:xfrm>
            <a:off x="252162" y="655779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A)</a:t>
            </a:r>
            <a:endParaRPr lang="ko-KR" altLang="en-US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A40C48-C505-483A-9064-E4E45EC7BFD6}"/>
              </a:ext>
            </a:extLst>
          </p:cNvPr>
          <p:cNvSpPr txBox="1"/>
          <p:nvPr/>
        </p:nvSpPr>
        <p:spPr>
          <a:xfrm>
            <a:off x="6204014" y="649071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B)</a:t>
            </a:r>
            <a:endParaRPr lang="ko-KR" altLang="en-US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A220FD1-5CEE-4686-BB43-FC47D12A9340}"/>
              </a:ext>
            </a:extLst>
          </p:cNvPr>
          <p:cNvSpPr txBox="1"/>
          <p:nvPr/>
        </p:nvSpPr>
        <p:spPr>
          <a:xfrm>
            <a:off x="252162" y="3786493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C)</a:t>
            </a:r>
            <a:endParaRPr lang="ko-KR" altLang="en-US" sz="12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CA5DB6-D520-4252-8CB3-BAA196C604E0}"/>
              </a:ext>
            </a:extLst>
          </p:cNvPr>
          <p:cNvSpPr txBox="1"/>
          <p:nvPr/>
        </p:nvSpPr>
        <p:spPr>
          <a:xfrm>
            <a:off x="6204014" y="377978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D)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340318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AA335C5F-FC98-42D7-A9D8-17B944C18A5D}"/>
              </a:ext>
            </a:extLst>
          </p:cNvPr>
          <p:cNvSpPr txBox="1"/>
          <p:nvPr/>
        </p:nvSpPr>
        <p:spPr>
          <a:xfrm>
            <a:off x="252162" y="655779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A)</a:t>
            </a:r>
            <a:endParaRPr lang="ko-KR" altLang="en-US" sz="12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0A40C48-C505-483A-9064-E4E45EC7BFD6}"/>
              </a:ext>
            </a:extLst>
          </p:cNvPr>
          <p:cNvSpPr txBox="1"/>
          <p:nvPr/>
        </p:nvSpPr>
        <p:spPr>
          <a:xfrm>
            <a:off x="6204014" y="649071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B)</a:t>
            </a:r>
            <a:endParaRPr lang="ko-KR" altLang="en-US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A220FD1-5CEE-4686-BB43-FC47D12A9340}"/>
              </a:ext>
            </a:extLst>
          </p:cNvPr>
          <p:cNvSpPr txBox="1"/>
          <p:nvPr/>
        </p:nvSpPr>
        <p:spPr>
          <a:xfrm>
            <a:off x="252162" y="3786493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C)</a:t>
            </a:r>
            <a:endParaRPr lang="ko-KR" altLang="en-US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0CA5DB6-D520-4252-8CB3-BAA196C604E0}"/>
              </a:ext>
            </a:extLst>
          </p:cNvPr>
          <p:cNvSpPr txBox="1"/>
          <p:nvPr/>
        </p:nvSpPr>
        <p:spPr>
          <a:xfrm>
            <a:off x="6204014" y="377978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D)</a:t>
            </a:r>
            <a:endParaRPr lang="ko-KR" altLang="en-US" sz="1200" dirty="0"/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161" y="932583"/>
            <a:ext cx="5909189" cy="2880000"/>
          </a:xfrm>
          <a:prstGeom prst="rect">
            <a:avLst/>
          </a:prstGeom>
        </p:spPr>
      </p:pic>
      <p:pic>
        <p:nvPicPr>
          <p:cNvPr id="24" name="그림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2162" y="3978000"/>
            <a:ext cx="5909189" cy="2880000"/>
          </a:xfrm>
          <a:prstGeom prst="rect">
            <a:avLst/>
          </a:prstGeom>
        </p:spPr>
      </p:pic>
      <p:pic>
        <p:nvPicPr>
          <p:cNvPr id="25" name="그림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04013" y="932778"/>
            <a:ext cx="5909189" cy="2880000"/>
          </a:xfrm>
          <a:prstGeom prst="rect">
            <a:avLst/>
          </a:prstGeom>
        </p:spPr>
      </p:pic>
      <p:pic>
        <p:nvPicPr>
          <p:cNvPr id="26" name="그림 2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04014" y="3978000"/>
            <a:ext cx="5909189" cy="2880000"/>
          </a:xfrm>
          <a:prstGeom prst="rect">
            <a:avLst/>
          </a:prstGeom>
        </p:spPr>
      </p:pic>
      <p:sp>
        <p:nvSpPr>
          <p:cNvPr id="11" name="제목 1"/>
          <p:cNvSpPr>
            <a:spLocks noGrp="1"/>
          </p:cNvSpPr>
          <p:nvPr>
            <p:ph type="title"/>
          </p:nvPr>
        </p:nvSpPr>
        <p:spPr>
          <a:xfrm>
            <a:off x="-1" y="1"/>
            <a:ext cx="12084783" cy="965380"/>
          </a:xfrm>
        </p:spPr>
        <p:txBody>
          <a:bodyPr>
            <a:noAutofit/>
          </a:bodyPr>
          <a:lstStyle/>
          <a:p>
            <a:pPr algn="just" latinLnBrk="1">
              <a:lnSpc>
                <a:spcPct val="115000"/>
              </a:lnSpc>
              <a:spcAft>
                <a:spcPts val="1000"/>
              </a:spcAft>
            </a:pP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. Individual distribution of grade ≥3 lung complication (n=7). (A) Sorted by V20 of lung at re-RT; (B) sorted by cumulative V20 of lung; (C) sorted by re-RT techniques and V20 of lung at re-RT; (D) sorted by re-RT techniques and cumulative V20 of lung;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x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mplication; P, proton beam therapy; X, X-ray beam therapy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78515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162" y="3982214"/>
            <a:ext cx="5902382" cy="2880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6722" y="3982214"/>
            <a:ext cx="5902382" cy="2880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6F59C81-B64E-449E-AF48-48519C3E2C0F}"/>
              </a:ext>
            </a:extLst>
          </p:cNvPr>
          <p:cNvSpPr txBox="1"/>
          <p:nvPr/>
        </p:nvSpPr>
        <p:spPr>
          <a:xfrm>
            <a:off x="252162" y="655779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A)</a:t>
            </a:r>
            <a:endParaRPr lang="ko-KR" altLang="en-US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BFACF2A-1201-4DED-914F-E8A80A3D54D5}"/>
              </a:ext>
            </a:extLst>
          </p:cNvPr>
          <p:cNvSpPr txBox="1"/>
          <p:nvPr/>
        </p:nvSpPr>
        <p:spPr>
          <a:xfrm>
            <a:off x="6204014" y="649071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B)</a:t>
            </a:r>
            <a:endParaRPr lang="ko-KR" altLang="en-US" sz="12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FE10295-BF77-4C5A-B9F3-355DB00EB43C}"/>
              </a:ext>
            </a:extLst>
          </p:cNvPr>
          <p:cNvSpPr txBox="1"/>
          <p:nvPr/>
        </p:nvSpPr>
        <p:spPr>
          <a:xfrm>
            <a:off x="252162" y="3786493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C)</a:t>
            </a:r>
            <a:endParaRPr lang="ko-KR" altLang="en-US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83B06B2-BFEC-4F36-82EA-117C8ECE0F38}"/>
              </a:ext>
            </a:extLst>
          </p:cNvPr>
          <p:cNvSpPr txBox="1"/>
          <p:nvPr/>
        </p:nvSpPr>
        <p:spPr>
          <a:xfrm>
            <a:off x="6204014" y="377978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D)</a:t>
            </a:r>
            <a:endParaRPr lang="ko-KR" altLang="en-US" sz="12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2162" y="873890"/>
            <a:ext cx="5902382" cy="2880000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96722" y="878891"/>
            <a:ext cx="5902382" cy="2880000"/>
          </a:xfrm>
          <a:prstGeom prst="rect">
            <a:avLst/>
          </a:prstGeom>
        </p:spPr>
      </p:pic>
      <p:sp>
        <p:nvSpPr>
          <p:cNvPr id="11" name="제목 1"/>
          <p:cNvSpPr>
            <a:spLocks noGrp="1"/>
          </p:cNvSpPr>
          <p:nvPr>
            <p:ph type="title"/>
          </p:nvPr>
        </p:nvSpPr>
        <p:spPr>
          <a:xfrm>
            <a:off x="-1" y="1"/>
            <a:ext cx="12084783" cy="965380"/>
          </a:xfrm>
        </p:spPr>
        <p:txBody>
          <a:bodyPr>
            <a:noAutofit/>
          </a:bodyPr>
          <a:lstStyle/>
          <a:p>
            <a:pPr algn="just" latinLnBrk="1">
              <a:lnSpc>
                <a:spcPct val="115000"/>
              </a:lnSpc>
              <a:spcAft>
                <a:spcPts val="1000"/>
              </a:spcAft>
            </a:pP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. Individual distribution of grade ≥3 esophageal complication (n=7). (A) Sorted by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ax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sophagus at re-RT; (B) sorted by cumulative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ax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sophagus; (C) sorted by re-RT techniques and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ax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sophagus at re-RT; (D) sorted by re-RT techniques and cumulative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ax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sophagus;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x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mplication; P, proton beam therapy; X, X-ray beam therapy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47546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E8DE3EF-50FC-4762-9734-92CED1B2543C}"/>
              </a:ext>
            </a:extLst>
          </p:cNvPr>
          <p:cNvSpPr txBox="1"/>
          <p:nvPr/>
        </p:nvSpPr>
        <p:spPr>
          <a:xfrm>
            <a:off x="252162" y="655779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A)</a:t>
            </a:r>
            <a:endParaRPr lang="ko-KR" alt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072831D-4183-4049-B6B2-3FEBF0C3A38A}"/>
              </a:ext>
            </a:extLst>
          </p:cNvPr>
          <p:cNvSpPr txBox="1"/>
          <p:nvPr/>
        </p:nvSpPr>
        <p:spPr>
          <a:xfrm>
            <a:off x="6204014" y="649071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B)</a:t>
            </a:r>
            <a:endParaRPr lang="ko-KR" alt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9AB5DB9-C2BD-4D37-B917-5AC3940ABB65}"/>
              </a:ext>
            </a:extLst>
          </p:cNvPr>
          <p:cNvSpPr txBox="1"/>
          <p:nvPr/>
        </p:nvSpPr>
        <p:spPr>
          <a:xfrm>
            <a:off x="252162" y="3786493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C)</a:t>
            </a:r>
            <a:endParaRPr lang="ko-KR" alt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C2A1E67-EBC0-461F-B171-F1618F378633}"/>
              </a:ext>
            </a:extLst>
          </p:cNvPr>
          <p:cNvSpPr txBox="1"/>
          <p:nvPr/>
        </p:nvSpPr>
        <p:spPr>
          <a:xfrm>
            <a:off x="6204014" y="377978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(D)</a:t>
            </a:r>
            <a:endParaRPr lang="ko-KR" altLang="en-US" sz="1200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402" y="3978000"/>
            <a:ext cx="5895910" cy="288000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4014" y="858606"/>
            <a:ext cx="5895910" cy="2880000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04014" y="3978000"/>
            <a:ext cx="5895910" cy="2880000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4052" y="858606"/>
            <a:ext cx="5895910" cy="2880000"/>
          </a:xfrm>
          <a:prstGeom prst="rect">
            <a:avLst/>
          </a:prstGeom>
        </p:spPr>
      </p:pic>
      <p:sp>
        <p:nvSpPr>
          <p:cNvPr id="11" name="제목 1"/>
          <p:cNvSpPr>
            <a:spLocks noGrp="1"/>
          </p:cNvSpPr>
          <p:nvPr>
            <p:ph type="title"/>
          </p:nvPr>
        </p:nvSpPr>
        <p:spPr>
          <a:xfrm>
            <a:off x="-1" y="1"/>
            <a:ext cx="12084783" cy="965380"/>
          </a:xfrm>
        </p:spPr>
        <p:txBody>
          <a:bodyPr>
            <a:noAutofit/>
          </a:bodyPr>
          <a:lstStyle/>
          <a:p>
            <a:pPr algn="just" latinLnBrk="1">
              <a:lnSpc>
                <a:spcPct val="115000"/>
              </a:lnSpc>
              <a:spcAft>
                <a:spcPts val="1000"/>
              </a:spcAft>
            </a:pP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. Individual distribution of grade ≥3 esophageal complication (n=7). (A) Sorted by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ean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sophagus at re-RT; (B) sorted by cumulative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ean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sophagus; (C) sorted by re-RT techniques and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ean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sophagus at re-RT; (D) sorted by re-RT techniques and cumulative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ean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sophagus;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x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mplication; P, proton beam therapy; X, X-ray beam therapy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0244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</TotalTime>
  <Words>368</Words>
  <Application>Microsoft Office PowerPoint</Application>
  <PresentationFormat>Widescreen</PresentationFormat>
  <Paragraphs>2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Times New Roman</vt:lpstr>
      <vt:lpstr>Office 테마</vt:lpstr>
      <vt:lpstr>Figure S1. . Individual distribution of grade ≥3 lung complication (n=7). (A) Sorted by Dmean of lung at re-RT; (B) sorted by cumulative Dmean of lung; (C) sorted by re-RT techniques and Dmean of lung at re-RT; (D) sorted by re-RT techniques and cumulative Dmean of lung; Cx, complication; P, proton beam therapy; X, X-ray beam therapy</vt:lpstr>
      <vt:lpstr>Figure S2. . Individual distribution of grade ≥3 lung complication (n=7). (A) Sorted by V20 of lung at re-RT; (B) sorted by cumulative V20 of lung; (C) sorted by re-RT techniques and V20 of lung at re-RT; (D) sorted by re-RT techniques and cumulative V20 of lung; Cx, complication; P, proton beam therapy; X, X-ray beam therapy</vt:lpstr>
      <vt:lpstr>Figure S3. . Individual distribution of grade ≥3 esophageal complication (n=7). (A) Sorted by Dmax of esophagus at re-RT; (B) sorted by cumulative Dmax of esophagus; (C) sorted by re-RT techniques and Dmax of esophagus at re-RT; (D) sorted by re-RT techniques and cumulative Dmax of esophagus; Cx, complication; P, proton beam therapy; X, X-ray beam therapy</vt:lpstr>
      <vt:lpstr>Figure S4. . Individual distribution of grade ≥3 esophageal complication (n=7). (A) Sorted by Dmean of esophagus at re-RT; (B) sorted by cumulative Dmean of esophagus; (C) sorted by re-RT techniques and Dmean of esophagus at re-RT; (D) sorted by re-RT techniques and cumulative Dmean of esophagus; Cx, complication; P, proton beam therapy; X, X-ray beam therapy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경미</dc:creator>
  <cp:lastModifiedBy>Yingying Qi</cp:lastModifiedBy>
  <cp:revision>18</cp:revision>
  <dcterms:created xsi:type="dcterms:W3CDTF">2021-09-08T01:12:52Z</dcterms:created>
  <dcterms:modified xsi:type="dcterms:W3CDTF">2022-02-16T05:40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C:\Users\DM500TCZ-AD3A\Desktop\Proton re-RT\논문쓰기\Figures (supplementary figures 포함).pptx</vt:lpwstr>
  </property>
</Properties>
</file>